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7" d="100"/>
          <a:sy n="87" d="100"/>
        </p:scale>
        <p:origin x="29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7169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990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12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0800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6505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313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432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4741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4646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9684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1094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DB063-29B3-457B-8FA5-2BF6C07671CB}" type="datetimeFigureOut">
              <a:rPr lang="en-US" smtClean="0"/>
              <a:t>4/2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961D9-1B92-4616-8AF1-519BEF11F1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9806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g"/><Relationship Id="rId13" Type="http://schemas.openxmlformats.org/officeDocument/2006/relationships/image" Target="../media/image8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7.jpg"/><Relationship Id="rId2" Type="http://schemas.openxmlformats.org/officeDocument/2006/relationships/image" Target="../media/image1.png"/><Relationship Id="rId16" Type="http://schemas.openxmlformats.org/officeDocument/2006/relationships/image" Target="../media/image1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5" Type="http://schemas.microsoft.com/office/2007/relationships/hdphoto" Target="../media/hdphoto2.wdp"/><Relationship Id="rId15" Type="http://schemas.openxmlformats.org/officeDocument/2006/relationships/image" Target="../media/image10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9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13" Type="http://schemas.microsoft.com/office/2007/relationships/hdphoto" Target="../media/hdphoto7.wdp"/><Relationship Id="rId3" Type="http://schemas.microsoft.com/office/2007/relationships/hdphoto" Target="../media/hdphoto5.wdp"/><Relationship Id="rId7" Type="http://schemas.openxmlformats.org/officeDocument/2006/relationships/image" Target="../media/image15.jpg"/><Relationship Id="rId12" Type="http://schemas.openxmlformats.org/officeDocument/2006/relationships/image" Target="../media/image20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microsoft.com/office/2007/relationships/hdphoto" Target="../media/hdphoto6.wdp"/><Relationship Id="rId11" Type="http://schemas.openxmlformats.org/officeDocument/2006/relationships/image" Target="../media/image19.jpeg"/><Relationship Id="rId5" Type="http://schemas.openxmlformats.org/officeDocument/2006/relationships/image" Target="../media/image14.png"/><Relationship Id="rId10" Type="http://schemas.openxmlformats.org/officeDocument/2006/relationships/image" Target="../media/image18.jpeg"/><Relationship Id="rId4" Type="http://schemas.openxmlformats.org/officeDocument/2006/relationships/image" Target="../media/image13.jpeg"/><Relationship Id="rId9" Type="http://schemas.openxmlformats.org/officeDocument/2006/relationships/image" Target="../media/image17.jpeg"/><Relationship Id="rId14" Type="http://schemas.openxmlformats.org/officeDocument/2006/relationships/image" Target="../media/image2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jpg"/><Relationship Id="rId13" Type="http://schemas.openxmlformats.org/officeDocument/2006/relationships/image" Target="../media/image30.png"/><Relationship Id="rId18" Type="http://schemas.microsoft.com/office/2007/relationships/hdphoto" Target="../media/hdphoto13.wdp"/><Relationship Id="rId3" Type="http://schemas.openxmlformats.org/officeDocument/2006/relationships/image" Target="../media/image23.jpg"/><Relationship Id="rId7" Type="http://schemas.openxmlformats.org/officeDocument/2006/relationships/image" Target="../media/image26.jpg"/><Relationship Id="rId12" Type="http://schemas.microsoft.com/office/2007/relationships/hdphoto" Target="../media/hdphoto10.wdp"/><Relationship Id="rId17" Type="http://schemas.openxmlformats.org/officeDocument/2006/relationships/image" Target="../media/image32.png"/><Relationship Id="rId2" Type="http://schemas.openxmlformats.org/officeDocument/2006/relationships/image" Target="../media/image22.jpg"/><Relationship Id="rId16" Type="http://schemas.microsoft.com/office/2007/relationships/hdphoto" Target="../media/hdphoto12.wdp"/><Relationship Id="rId20" Type="http://schemas.microsoft.com/office/2007/relationships/hdphoto" Target="../media/hdphoto14.wdp"/><Relationship Id="rId1" Type="http://schemas.openxmlformats.org/officeDocument/2006/relationships/slideLayout" Target="../slideLayouts/slideLayout1.xml"/><Relationship Id="rId6" Type="http://schemas.microsoft.com/office/2007/relationships/hdphoto" Target="../media/hdphoto8.wdp"/><Relationship Id="rId11" Type="http://schemas.openxmlformats.org/officeDocument/2006/relationships/image" Target="../media/image29.png"/><Relationship Id="rId5" Type="http://schemas.openxmlformats.org/officeDocument/2006/relationships/image" Target="../media/image25.png"/><Relationship Id="rId15" Type="http://schemas.openxmlformats.org/officeDocument/2006/relationships/image" Target="../media/image31.png"/><Relationship Id="rId10" Type="http://schemas.microsoft.com/office/2007/relationships/hdphoto" Target="../media/hdphoto9.wdp"/><Relationship Id="rId19" Type="http://schemas.openxmlformats.org/officeDocument/2006/relationships/image" Target="../media/image33.png"/><Relationship Id="rId4" Type="http://schemas.openxmlformats.org/officeDocument/2006/relationships/image" Target="../media/image24.jpg"/><Relationship Id="rId9" Type="http://schemas.openxmlformats.org/officeDocument/2006/relationships/image" Target="../media/image28.png"/><Relationship Id="rId14" Type="http://schemas.microsoft.com/office/2007/relationships/hdphoto" Target="../media/hdphoto11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3" Type="http://schemas.openxmlformats.org/officeDocument/2006/relationships/image" Target="../media/image35.emf"/><Relationship Id="rId7" Type="http://schemas.openxmlformats.org/officeDocument/2006/relationships/image" Target="../media/image39.emf"/><Relationship Id="rId12" Type="http://schemas.openxmlformats.org/officeDocument/2006/relationships/image" Target="../media/image44.emf"/><Relationship Id="rId2" Type="http://schemas.openxmlformats.org/officeDocument/2006/relationships/image" Target="../media/image34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emf"/><Relationship Id="rId11" Type="http://schemas.openxmlformats.org/officeDocument/2006/relationships/image" Target="../media/image43.emf"/><Relationship Id="rId5" Type="http://schemas.openxmlformats.org/officeDocument/2006/relationships/image" Target="../media/image37.emf"/><Relationship Id="rId10" Type="http://schemas.openxmlformats.org/officeDocument/2006/relationships/image" Target="../media/image42.emf"/><Relationship Id="rId4" Type="http://schemas.openxmlformats.org/officeDocument/2006/relationships/image" Target="../media/image36.emf"/><Relationship Id="rId9" Type="http://schemas.openxmlformats.org/officeDocument/2006/relationships/image" Target="../media/image41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290BB78-03B9-094C-82B2-84EACE0D5161}"/>
              </a:ext>
            </a:extLst>
          </p:cNvPr>
          <p:cNvSpPr/>
          <p:nvPr/>
        </p:nvSpPr>
        <p:spPr>
          <a:xfrm>
            <a:off x="189000" y="432000"/>
            <a:ext cx="6480000" cy="8280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5748E49-E110-1F42-BC4F-07972F4AF147}"/>
              </a:ext>
            </a:extLst>
          </p:cNvPr>
          <p:cNvSpPr txBox="1"/>
          <p:nvPr/>
        </p:nvSpPr>
        <p:spPr>
          <a:xfrm rot="16200000">
            <a:off x="95013" y="1437657"/>
            <a:ext cx="1254589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 2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54A04C69-B137-374F-98A9-78EE8C066F09}"/>
              </a:ext>
            </a:extLst>
          </p:cNvPr>
          <p:cNvSpPr/>
          <p:nvPr/>
        </p:nvSpPr>
        <p:spPr>
          <a:xfrm>
            <a:off x="3600392" y="744773"/>
            <a:ext cx="1244336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JH-2-002</a:t>
            </a:r>
          </a:p>
        </p:txBody>
      </p:sp>
      <p:pic>
        <p:nvPicPr>
          <p:cNvPr id="31" name="Picture 30" descr="A picture containing several, different&#10;&#10;Description automatically generated">
            <a:extLst>
              <a:ext uri="{FF2B5EF4-FFF2-40B4-BE49-F238E27FC236}">
                <a16:creationId xmlns:a16="http://schemas.microsoft.com/office/drawing/2014/main" id="{AE22C725-573D-ED47-AF39-461CD842C5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alphaModFix/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68" t="28099" r="50585" b="42079"/>
          <a:stretch/>
        </p:blipFill>
        <p:spPr>
          <a:xfrm>
            <a:off x="3594923" y="871899"/>
            <a:ext cx="1249805" cy="1254608"/>
          </a:xfrm>
          <a:prstGeom prst="rect">
            <a:avLst/>
          </a:prstGeom>
        </p:spPr>
      </p:pic>
      <p:pic>
        <p:nvPicPr>
          <p:cNvPr id="32" name="Picture 31" descr="A picture containing doughnut, donut, different, indoor&#10;&#10;Description automatically generated">
            <a:extLst>
              <a:ext uri="{FF2B5EF4-FFF2-40B4-BE49-F238E27FC236}">
                <a16:creationId xmlns:a16="http://schemas.microsoft.com/office/drawing/2014/main" id="{B46CF82F-F707-A149-91E7-ACC3257F089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428" t="43523" r="60326" b="25489"/>
          <a:stretch/>
        </p:blipFill>
        <p:spPr>
          <a:xfrm>
            <a:off x="2192915" y="871965"/>
            <a:ext cx="1254971" cy="1254614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EC5C1156-1FA8-FE45-AFED-3733595C2062}"/>
              </a:ext>
            </a:extLst>
          </p:cNvPr>
          <p:cNvSpPr/>
          <p:nvPr/>
        </p:nvSpPr>
        <p:spPr>
          <a:xfrm>
            <a:off x="2192915" y="747585"/>
            <a:ext cx="1244853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JH-2-031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CF7268AA-60F2-8C4E-825F-7A01C5C61AFB}"/>
              </a:ext>
            </a:extLst>
          </p:cNvPr>
          <p:cNvSpPr/>
          <p:nvPr/>
        </p:nvSpPr>
        <p:spPr>
          <a:xfrm>
            <a:off x="791062" y="745698"/>
            <a:ext cx="125475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N-2</a:t>
            </a:r>
          </a:p>
        </p:txBody>
      </p:sp>
      <p:pic>
        <p:nvPicPr>
          <p:cNvPr id="37" name="Picture 36" descr="A picture containing grater, basement, microphone&#10;&#10;Description automatically generated">
            <a:extLst>
              <a:ext uri="{FF2B5EF4-FFF2-40B4-BE49-F238E27FC236}">
                <a16:creationId xmlns:a16="http://schemas.microsoft.com/office/drawing/2014/main" id="{C5CABE86-3212-9144-80D4-F5F94D1BA01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alphaModFix/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224" t="15469" r="25879" b="52984"/>
          <a:stretch/>
        </p:blipFill>
        <p:spPr>
          <a:xfrm>
            <a:off x="790908" y="871928"/>
            <a:ext cx="1254970" cy="1254608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079880C2-E008-904E-A1E6-1510E803422A}"/>
              </a:ext>
            </a:extLst>
          </p:cNvPr>
          <p:cNvSpPr txBox="1"/>
          <p:nvPr/>
        </p:nvSpPr>
        <p:spPr>
          <a:xfrm>
            <a:off x="791063" y="2217889"/>
            <a:ext cx="4053666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ell aggregation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7CDD2CB5-1495-2545-894D-6B7C5466F2B6}"/>
              </a:ext>
            </a:extLst>
          </p:cNvPr>
          <p:cNvCxnSpPr>
            <a:cxnSpLocks/>
          </p:cNvCxnSpPr>
          <p:nvPr/>
        </p:nvCxnSpPr>
        <p:spPr>
          <a:xfrm>
            <a:off x="790908" y="2204911"/>
            <a:ext cx="406192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37E8B4A1-65CB-0D4C-BF16-3D84C36D9DC6}"/>
              </a:ext>
            </a:extLst>
          </p:cNvPr>
          <p:cNvSpPr txBox="1"/>
          <p:nvPr/>
        </p:nvSpPr>
        <p:spPr>
          <a:xfrm>
            <a:off x="483254" y="61822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1" name="Picture 40" descr="A picture containing indoor, different, several, group&#10;&#10;Description automatically generated">
            <a:extLst>
              <a:ext uri="{FF2B5EF4-FFF2-40B4-BE49-F238E27FC236}">
                <a16:creationId xmlns:a16="http://schemas.microsoft.com/office/drawing/2014/main" id="{9C654250-C64E-F449-AF3B-4CF90D0B23BD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44" t="42403" r="35635" b="26656"/>
          <a:stretch/>
        </p:blipFill>
        <p:spPr>
          <a:xfrm>
            <a:off x="790830" y="2640025"/>
            <a:ext cx="1254984" cy="1251407"/>
          </a:xfrm>
          <a:prstGeom prst="rect">
            <a:avLst/>
          </a:prstGeom>
        </p:spPr>
      </p:pic>
      <p:sp>
        <p:nvSpPr>
          <p:cNvPr id="42" name="Rectangle 41">
            <a:extLst>
              <a:ext uri="{FF2B5EF4-FFF2-40B4-BE49-F238E27FC236}">
                <a16:creationId xmlns:a16="http://schemas.microsoft.com/office/drawing/2014/main" id="{300B1196-8978-274F-80E6-E89404DD3ED7}"/>
              </a:ext>
            </a:extLst>
          </p:cNvPr>
          <p:cNvSpPr/>
          <p:nvPr/>
        </p:nvSpPr>
        <p:spPr>
          <a:xfrm>
            <a:off x="791063" y="2506784"/>
            <a:ext cx="125475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U-225</a:t>
            </a:r>
          </a:p>
        </p:txBody>
      </p:sp>
      <p:pic>
        <p:nvPicPr>
          <p:cNvPr id="43" name="Picture 42">
            <a:extLst>
              <a:ext uri="{FF2B5EF4-FFF2-40B4-BE49-F238E27FC236}">
                <a16:creationId xmlns:a16="http://schemas.microsoft.com/office/drawing/2014/main" id="{BBF2E018-51FE-D649-B205-B6EDC3928189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alphaModFix/>
          </a:blip>
          <a:srcRect l="60686" t="49680" b="3620"/>
          <a:stretch/>
        </p:blipFill>
        <p:spPr>
          <a:xfrm>
            <a:off x="2194342" y="2639639"/>
            <a:ext cx="1254983" cy="1248068"/>
          </a:xfrm>
          <a:prstGeom prst="rect">
            <a:avLst/>
          </a:prstGeom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0C10AFAC-EEC7-1E43-86EA-7C1B0175A6BB}"/>
              </a:ext>
            </a:extLst>
          </p:cNvPr>
          <p:cNvSpPr/>
          <p:nvPr/>
        </p:nvSpPr>
        <p:spPr>
          <a:xfrm>
            <a:off x="2194456" y="2506686"/>
            <a:ext cx="1254753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U-356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03FBAA8-979C-9D48-AD38-2CA81A6FDCE0}"/>
              </a:ext>
            </a:extLst>
          </p:cNvPr>
          <p:cNvSpPr txBox="1"/>
          <p:nvPr/>
        </p:nvSpPr>
        <p:spPr>
          <a:xfrm>
            <a:off x="791062" y="3974573"/>
            <a:ext cx="5460105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ells remain dispersed</a:t>
            </a:r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7FE84F15-D349-C44D-A1C5-B9A3094E50DE}"/>
              </a:ext>
            </a:extLst>
          </p:cNvPr>
          <p:cNvSpPr/>
          <p:nvPr/>
        </p:nvSpPr>
        <p:spPr>
          <a:xfrm>
            <a:off x="3594923" y="2506686"/>
            <a:ext cx="1254752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U-386</a:t>
            </a:r>
          </a:p>
        </p:txBody>
      </p:sp>
      <p:pic>
        <p:nvPicPr>
          <p:cNvPr id="47" name="Picture 46" descr="A picture containing weapon&#10;&#10;Description automatically generated">
            <a:extLst>
              <a:ext uri="{FF2B5EF4-FFF2-40B4-BE49-F238E27FC236}">
                <a16:creationId xmlns:a16="http://schemas.microsoft.com/office/drawing/2014/main" id="{82E65B0C-AD7B-C642-BF9F-60B97B8B3617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alphaModFix/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017" t="41182" r="42984" b="27074"/>
          <a:stretch/>
        </p:blipFill>
        <p:spPr>
          <a:xfrm>
            <a:off x="3597853" y="2634097"/>
            <a:ext cx="1254982" cy="1248054"/>
          </a:xfrm>
          <a:prstGeom prst="rect">
            <a:avLst/>
          </a:prstGeom>
        </p:spPr>
      </p:pic>
      <p:pic>
        <p:nvPicPr>
          <p:cNvPr id="48" name="Picture 47" descr="A picture containing different, several&#10;&#10;Description automatically generated">
            <a:extLst>
              <a:ext uri="{FF2B5EF4-FFF2-40B4-BE49-F238E27FC236}">
                <a16:creationId xmlns:a16="http://schemas.microsoft.com/office/drawing/2014/main" id="{D85943BC-8CB5-EE43-8B77-B37A96A130F5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56" t="47405" r="10848" b="19599"/>
          <a:stretch/>
        </p:blipFill>
        <p:spPr>
          <a:xfrm>
            <a:off x="5001362" y="2632561"/>
            <a:ext cx="1249805" cy="1248054"/>
          </a:xfrm>
          <a:prstGeom prst="rect">
            <a:avLst/>
          </a:prstGeom>
        </p:spPr>
      </p:pic>
      <p:sp>
        <p:nvSpPr>
          <p:cNvPr id="49" name="Rectangle 48">
            <a:extLst>
              <a:ext uri="{FF2B5EF4-FFF2-40B4-BE49-F238E27FC236}">
                <a16:creationId xmlns:a16="http://schemas.microsoft.com/office/drawing/2014/main" id="{6B36B033-7CF6-DE44-BB34-ACCBDDE18EF5}"/>
              </a:ext>
            </a:extLst>
          </p:cNvPr>
          <p:cNvSpPr/>
          <p:nvPr/>
        </p:nvSpPr>
        <p:spPr>
          <a:xfrm>
            <a:off x="4995389" y="2506686"/>
            <a:ext cx="1231009" cy="123111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U-436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AD8DF2A4-4D52-4349-B036-AC2C2A20E5C3}"/>
              </a:ext>
            </a:extLst>
          </p:cNvPr>
          <p:cNvCxnSpPr>
            <a:cxnSpLocks/>
          </p:cNvCxnSpPr>
          <p:nvPr/>
        </p:nvCxnSpPr>
        <p:spPr>
          <a:xfrm flipV="1">
            <a:off x="790830" y="3952325"/>
            <a:ext cx="5460337" cy="914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0901FBC-1A41-B54F-9971-919FF8530568}"/>
              </a:ext>
            </a:extLst>
          </p:cNvPr>
          <p:cNvSpPr txBox="1"/>
          <p:nvPr/>
        </p:nvSpPr>
        <p:spPr>
          <a:xfrm rot="16200000">
            <a:off x="102853" y="3190031"/>
            <a:ext cx="1238909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ay 2</a:t>
            </a: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B83731A8-416C-AB47-87F8-DA1EB050BF80}"/>
              </a:ext>
            </a:extLst>
          </p:cNvPr>
          <p:cNvGrpSpPr/>
          <p:nvPr/>
        </p:nvGrpSpPr>
        <p:grpSpPr>
          <a:xfrm>
            <a:off x="532138" y="4366154"/>
            <a:ext cx="3164849" cy="2920590"/>
            <a:chOff x="5782251" y="1087143"/>
            <a:chExt cx="3164849" cy="2920590"/>
          </a:xfrm>
        </p:grpSpPr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2976ABD1-C842-7D48-A1C1-082C1121C03C}"/>
                </a:ext>
              </a:extLst>
            </p:cNvPr>
            <p:cNvGrpSpPr/>
            <p:nvPr/>
          </p:nvGrpSpPr>
          <p:grpSpPr>
            <a:xfrm>
              <a:off x="5982848" y="1203989"/>
              <a:ext cx="2964252" cy="2673567"/>
              <a:chOff x="5982848" y="1203989"/>
              <a:chExt cx="2964252" cy="2673567"/>
            </a:xfrm>
          </p:grpSpPr>
          <p:pic>
            <p:nvPicPr>
              <p:cNvPr id="60" name="Picture 59">
                <a:extLst>
                  <a:ext uri="{FF2B5EF4-FFF2-40B4-BE49-F238E27FC236}">
                    <a16:creationId xmlns:a16="http://schemas.microsoft.com/office/drawing/2014/main" id="{631F7893-EF68-8C48-9DAB-2E855F66D99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373" t="22491" r="520" b="15634"/>
              <a:stretch/>
            </p:blipFill>
            <p:spPr>
              <a:xfrm>
                <a:off x="6324036" y="2622948"/>
                <a:ext cx="1254438" cy="1254608"/>
              </a:xfrm>
              <a:prstGeom prst="rect">
                <a:avLst/>
              </a:prstGeom>
            </p:spPr>
          </p:pic>
          <p:pic>
            <p:nvPicPr>
              <p:cNvPr id="61" name="Picture 60">
                <a:extLst>
                  <a:ext uri="{FF2B5EF4-FFF2-40B4-BE49-F238E27FC236}">
                    <a16:creationId xmlns:a16="http://schemas.microsoft.com/office/drawing/2014/main" id="{B5EC3FAD-ADF3-1C44-835E-AA3E346587E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alphaModFix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155" t="21427" r="510" b="16515"/>
              <a:stretch/>
            </p:blipFill>
            <p:spPr>
              <a:xfrm>
                <a:off x="6324038" y="1333473"/>
                <a:ext cx="1254437" cy="1248227"/>
              </a:xfrm>
              <a:prstGeom prst="rect">
                <a:avLst/>
              </a:prstGeom>
            </p:spPr>
          </p:pic>
          <p:sp>
            <p:nvSpPr>
              <p:cNvPr id="62" name="Rectangle 61">
                <a:extLst>
                  <a:ext uri="{FF2B5EF4-FFF2-40B4-BE49-F238E27FC236}">
                    <a16:creationId xmlns:a16="http://schemas.microsoft.com/office/drawing/2014/main" id="{5E35E131-E9D3-E74D-ACCB-18C66C38F65C}"/>
                  </a:ext>
                </a:extLst>
              </p:cNvPr>
              <p:cNvSpPr/>
              <p:nvPr/>
            </p:nvSpPr>
            <p:spPr>
              <a:xfrm>
                <a:off x="6330607" y="1203990"/>
                <a:ext cx="1244337" cy="123111"/>
              </a:xfrm>
              <a:prstGeom prst="rect">
                <a:avLst/>
              </a:prstGeom>
            </p:spPr>
            <p:txBody>
              <a:bodyPr wrap="square" lIns="0" tIns="0" rIns="0" bIns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N-2</a:t>
                </a:r>
              </a:p>
            </p:txBody>
          </p:sp>
          <p:pic>
            <p:nvPicPr>
              <p:cNvPr id="63" name="Picture 62" descr="A picture containing weapon, telephone, close&#10;&#10;Description automatically generated">
                <a:extLst>
                  <a:ext uri="{FF2B5EF4-FFF2-40B4-BE49-F238E27FC236}">
                    <a16:creationId xmlns:a16="http://schemas.microsoft.com/office/drawing/2014/main" id="{2D99BBE6-417E-9848-A98E-C0D120663E5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158" t="12467" r="16169" b="10295"/>
              <a:stretch/>
            </p:blipFill>
            <p:spPr>
              <a:xfrm>
                <a:off x="7697372" y="1329723"/>
                <a:ext cx="1249728" cy="1248226"/>
              </a:xfrm>
              <a:prstGeom prst="rect">
                <a:avLst/>
              </a:prstGeom>
            </p:spPr>
          </p:pic>
          <p:pic>
            <p:nvPicPr>
              <p:cNvPr id="64" name="Picture 63">
                <a:extLst>
                  <a:ext uri="{FF2B5EF4-FFF2-40B4-BE49-F238E27FC236}">
                    <a16:creationId xmlns:a16="http://schemas.microsoft.com/office/drawing/2014/main" id="{139D82B9-C9BA-514E-8C1C-1448833AA27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print">
                <a:alphaModFix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075" t="13112" r="16251" b="9257"/>
              <a:stretch/>
            </p:blipFill>
            <p:spPr>
              <a:xfrm>
                <a:off x="7697371" y="2622947"/>
                <a:ext cx="1249729" cy="1254609"/>
              </a:xfrm>
              <a:prstGeom prst="rect">
                <a:avLst/>
              </a:prstGeom>
            </p:spPr>
          </p:pic>
          <p:sp>
            <p:nvSpPr>
              <p:cNvPr id="65" name="Rectangle 64">
                <a:extLst>
                  <a:ext uri="{FF2B5EF4-FFF2-40B4-BE49-F238E27FC236}">
                    <a16:creationId xmlns:a16="http://schemas.microsoft.com/office/drawing/2014/main" id="{ABF53BFA-E3F5-C142-9B1F-C54B21FDBB25}"/>
                  </a:ext>
                </a:extLst>
              </p:cNvPr>
              <p:cNvSpPr/>
              <p:nvPr/>
            </p:nvSpPr>
            <p:spPr>
              <a:xfrm>
                <a:off x="7697371" y="1203989"/>
                <a:ext cx="1244337" cy="123111"/>
              </a:xfrm>
              <a:prstGeom prst="rect">
                <a:avLst/>
              </a:prstGeom>
            </p:spPr>
            <p:txBody>
              <a:bodyPr wrap="square" lIns="0" tIns="0" rIns="0" bIns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JH-2-031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FFF419ED-63B9-9E49-BD8F-36EB01CAC640}"/>
                  </a:ext>
                </a:extLst>
              </p:cNvPr>
              <p:cNvSpPr txBox="1"/>
              <p:nvPr/>
            </p:nvSpPr>
            <p:spPr>
              <a:xfrm rot="16200000">
                <a:off x="4775834" y="2547426"/>
                <a:ext cx="253714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ay 7</a:t>
                </a:r>
              </a:p>
            </p:txBody>
          </p:sp>
        </p:grp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F702A3F9-537E-7E49-8526-C9AACC917279}"/>
                </a:ext>
              </a:extLst>
            </p:cNvPr>
            <p:cNvSpPr txBox="1"/>
            <p:nvPr/>
          </p:nvSpPr>
          <p:spPr>
            <a:xfrm>
              <a:off x="5782251" y="1087143"/>
              <a:ext cx="2872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8E02A1A-3CF9-AB48-9DB1-9E70B3F35B2B}"/>
                </a:ext>
              </a:extLst>
            </p:cNvPr>
            <p:cNvSpPr txBox="1"/>
            <p:nvPr/>
          </p:nvSpPr>
          <p:spPr>
            <a:xfrm rot="16200000">
              <a:off x="5625327" y="1892277"/>
              <a:ext cx="124822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rightfield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CE6861C8-96B7-8B41-8EEB-57CDF2253751}"/>
                </a:ext>
              </a:extLst>
            </p:cNvPr>
            <p:cNvSpPr txBox="1"/>
            <p:nvPr/>
          </p:nvSpPr>
          <p:spPr>
            <a:xfrm rot="16200000" flipH="1">
              <a:off x="5621888" y="3185505"/>
              <a:ext cx="1248227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8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VE</a:t>
              </a:r>
            </a:p>
          </p:txBody>
        </p:sp>
        <p:cxnSp>
          <p:nvCxnSpPr>
            <p:cNvPr id="57" name="Straight Connector 56">
              <a:extLst>
                <a:ext uri="{FF2B5EF4-FFF2-40B4-BE49-F238E27FC236}">
                  <a16:creationId xmlns:a16="http://schemas.microsoft.com/office/drawing/2014/main" id="{FFE05BF1-3285-E442-BADF-BF9A26B8D3E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127938" y="1333473"/>
              <a:ext cx="2" cy="254408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9C2F18DF-70BE-F943-AEE2-15C52D19335B}"/>
                </a:ext>
              </a:extLst>
            </p:cNvPr>
            <p:cNvSpPr txBox="1"/>
            <p:nvPr/>
          </p:nvSpPr>
          <p:spPr>
            <a:xfrm>
              <a:off x="6324036" y="3884622"/>
              <a:ext cx="124980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pheroid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839D45D5-3711-F248-BB36-AFEF188A163A}"/>
                </a:ext>
              </a:extLst>
            </p:cNvPr>
            <p:cNvSpPr txBox="1"/>
            <p:nvPr/>
          </p:nvSpPr>
          <p:spPr>
            <a:xfrm>
              <a:off x="7691903" y="3884621"/>
              <a:ext cx="1249805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ggregate</a:t>
              </a:r>
            </a:p>
          </p:txBody>
        </p:sp>
      </p:grpSp>
      <p:sp>
        <p:nvSpPr>
          <p:cNvPr id="67" name="Rectangle 66">
            <a:extLst>
              <a:ext uri="{FF2B5EF4-FFF2-40B4-BE49-F238E27FC236}">
                <a16:creationId xmlns:a16="http://schemas.microsoft.com/office/drawing/2014/main" id="{FAFEC57B-3D23-BF4E-9D79-E3B79D13A4A4}"/>
              </a:ext>
            </a:extLst>
          </p:cNvPr>
          <p:cNvSpPr/>
          <p:nvPr/>
        </p:nvSpPr>
        <p:spPr>
          <a:xfrm>
            <a:off x="193801" y="7451645"/>
            <a:ext cx="6480000" cy="92333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EV1. Dissociated PDX tumor cells rarely form spheroids</a:t>
            </a:r>
          </a:p>
          <a:p>
            <a:pPr marL="228600" indent="-228600" algn="just">
              <a:buFont typeface="+mj-lt"/>
              <a:buAutoNum type="alphaUcPeriod"/>
            </a:pP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ative brightfield images of dissociated PDX tumor cells at two days of growth either beginning to aggregate or remain dispersed in collagen-free environment. Scale bars: </a:t>
            </a:r>
            <a:r>
              <a:rPr lang="en-US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 marL="228600" indent="-228600" algn="just">
              <a:buFont typeface="+mj-lt"/>
              <a:buAutoNum type="alphaUcPeriod"/>
            </a:pP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ative brightfield and fluorescent images showing either spheroid formation (MN-2) or continued cell aggregation (JH-2-031) after 7 days in culture in collagen-free environment. Cells were stained with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cein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M (live) and DRAQ5 (total). Scale bars: </a:t>
            </a:r>
            <a:r>
              <a:rPr lang="en-US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82452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290BB78-03B9-094C-82B2-84EACE0D5161}"/>
              </a:ext>
            </a:extLst>
          </p:cNvPr>
          <p:cNvSpPr/>
          <p:nvPr/>
        </p:nvSpPr>
        <p:spPr>
          <a:xfrm>
            <a:off x="189000" y="432000"/>
            <a:ext cx="6480000" cy="8280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919FD5E-4F84-A141-B2C6-A029A0760F8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729" t="36104" r="50309" b="28521"/>
          <a:stretch/>
        </p:blipFill>
        <p:spPr>
          <a:xfrm>
            <a:off x="382201" y="785322"/>
            <a:ext cx="991665" cy="99166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3B97633-F063-3E43-AA0C-DAC25B39CAE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88" t="34745" r="50625" b="28129"/>
          <a:stretch/>
        </p:blipFill>
        <p:spPr>
          <a:xfrm>
            <a:off x="382201" y="1795111"/>
            <a:ext cx="990379" cy="99037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AC4F71F7-3281-E94E-B058-A303D202AE2D}"/>
              </a:ext>
            </a:extLst>
          </p:cNvPr>
          <p:cNvSpPr txBox="1"/>
          <p:nvPr/>
        </p:nvSpPr>
        <p:spPr>
          <a:xfrm>
            <a:off x="382200" y="668485"/>
            <a:ext cx="990379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ST88-14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F05B30C-07E7-3149-B72F-F4993D3ED3D3}"/>
              </a:ext>
            </a:extLst>
          </p:cNvPr>
          <p:cNvSpPr txBox="1"/>
          <p:nvPr/>
        </p:nvSpPr>
        <p:spPr>
          <a:xfrm rot="16200000">
            <a:off x="-217566" y="1186106"/>
            <a:ext cx="1054589" cy="123111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Brightfield</a:t>
            </a:r>
          </a:p>
        </p:txBody>
      </p:sp>
      <p:pic>
        <p:nvPicPr>
          <p:cNvPr id="8" name="Picture 7" descr="A picture containing nature&#10;&#10;Description automatically generated">
            <a:extLst>
              <a:ext uri="{FF2B5EF4-FFF2-40B4-BE49-F238E27FC236}">
                <a16:creationId xmlns:a16="http://schemas.microsoft.com/office/drawing/2014/main" id="{723E0125-79C5-5940-8615-E64BF9D027B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alphaModFix/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085" t="28807" r="49453" b="43104"/>
          <a:stretch/>
        </p:blipFill>
        <p:spPr>
          <a:xfrm>
            <a:off x="3622805" y="788646"/>
            <a:ext cx="996739" cy="991666"/>
          </a:xfrm>
          <a:prstGeom prst="rect">
            <a:avLst/>
          </a:prstGeom>
        </p:spPr>
      </p:pic>
      <p:pic>
        <p:nvPicPr>
          <p:cNvPr id="9" name="Picture 8" descr="A picture containing star, dark, night sky, outdoor object&#10;&#10;Description automatically generated">
            <a:extLst>
              <a:ext uri="{FF2B5EF4-FFF2-40B4-BE49-F238E27FC236}">
                <a16:creationId xmlns:a16="http://schemas.microsoft.com/office/drawing/2014/main" id="{7184A850-F16A-DD45-92F6-D3316A052BD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37" t="28928" r="49492" b="43375"/>
          <a:stretch/>
        </p:blipFill>
        <p:spPr>
          <a:xfrm>
            <a:off x="3622803" y="1795111"/>
            <a:ext cx="995446" cy="986534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6BCBCA29-B104-B543-BF6F-863B0CA70F8C}"/>
              </a:ext>
            </a:extLst>
          </p:cNvPr>
          <p:cNvSpPr/>
          <p:nvPr/>
        </p:nvSpPr>
        <p:spPr>
          <a:xfrm>
            <a:off x="3625336" y="665861"/>
            <a:ext cx="990379" cy="123111"/>
          </a:xfrm>
          <a:prstGeom prst="rect">
            <a:avLst/>
          </a:prstGeom>
        </p:spPr>
        <p:txBody>
          <a:bodyPr wrap="square" t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U-386</a:t>
            </a:r>
          </a:p>
        </p:txBody>
      </p:sp>
      <p:pic>
        <p:nvPicPr>
          <p:cNvPr id="11" name="Content Placeholder 3">
            <a:extLst>
              <a:ext uri="{FF2B5EF4-FFF2-40B4-BE49-F238E27FC236}">
                <a16:creationId xmlns:a16="http://schemas.microsoft.com/office/drawing/2014/main" id="{EDEFABD6-5F49-954D-B998-2D3B1F05F81B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40" t="29272" r="45549" b="22104"/>
          <a:stretch/>
        </p:blipFill>
        <p:spPr>
          <a:xfrm>
            <a:off x="1526261" y="781984"/>
            <a:ext cx="987806" cy="990377"/>
          </a:xfrm>
          <a:prstGeom prst="rect">
            <a:avLst/>
          </a:prstGeom>
        </p:spPr>
      </p:pic>
      <p:pic>
        <p:nvPicPr>
          <p:cNvPr id="15" name="Content Placeholder 3">
            <a:extLst>
              <a:ext uri="{FF2B5EF4-FFF2-40B4-BE49-F238E27FC236}">
                <a16:creationId xmlns:a16="http://schemas.microsoft.com/office/drawing/2014/main" id="{5AC6F1DE-A9E4-814C-9D54-307B54528CAD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89" t="12948" r="37727" b="22323"/>
          <a:stretch/>
        </p:blipFill>
        <p:spPr bwMode="auto">
          <a:xfrm>
            <a:off x="2574530" y="783446"/>
            <a:ext cx="987812" cy="9968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C78284A4-5BC9-7644-AAD2-B99E4B5F033E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67" t="12064" r="37802" b="22911"/>
          <a:stretch/>
        </p:blipFill>
        <p:spPr>
          <a:xfrm>
            <a:off x="2575813" y="1795111"/>
            <a:ext cx="986527" cy="986531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728EF3A6-21D7-E548-B1B6-206AEAF3B8CA}"/>
              </a:ext>
            </a:extLst>
          </p:cNvPr>
          <p:cNvSpPr/>
          <p:nvPr/>
        </p:nvSpPr>
        <p:spPr>
          <a:xfrm>
            <a:off x="2568860" y="665861"/>
            <a:ext cx="991167" cy="123111"/>
          </a:xfrm>
          <a:prstGeom prst="rect">
            <a:avLst/>
          </a:prstGeom>
        </p:spPr>
        <p:txBody>
          <a:bodyPr wrap="square" t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U-368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31E1CB6A-72CF-1740-856F-3A912A360E54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93" t="28348" r="45543" b="22446"/>
          <a:stretch/>
        </p:blipFill>
        <p:spPr>
          <a:xfrm>
            <a:off x="1519977" y="1795111"/>
            <a:ext cx="986533" cy="986524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6D08DD72-A0D9-634B-9B1E-FBEB5D6EDC75}"/>
              </a:ext>
            </a:extLst>
          </p:cNvPr>
          <p:cNvSpPr/>
          <p:nvPr/>
        </p:nvSpPr>
        <p:spPr>
          <a:xfrm>
            <a:off x="1529858" y="666907"/>
            <a:ext cx="974952" cy="123111"/>
          </a:xfrm>
          <a:prstGeom prst="rect">
            <a:avLst/>
          </a:prstGeom>
        </p:spPr>
        <p:txBody>
          <a:bodyPr wrap="square" tIns="0" bIns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WU-356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89E2EF1-4719-1D4C-B89E-AF36EF1590F1}"/>
              </a:ext>
            </a:extLst>
          </p:cNvPr>
          <p:cNvSpPr txBox="1"/>
          <p:nvPr/>
        </p:nvSpPr>
        <p:spPr>
          <a:xfrm>
            <a:off x="4680009" y="665860"/>
            <a:ext cx="990379" cy="123111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JH-2-031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749E2F5A-B5C7-3240-9236-5FDAA8851721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alphaModFix/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56" t="32556" r="50223" b="29580"/>
          <a:stretch/>
        </p:blipFill>
        <p:spPr>
          <a:xfrm>
            <a:off x="4680009" y="781873"/>
            <a:ext cx="987810" cy="98781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D10659AF-EC52-634A-9C46-CC071D20AD24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alphaModFix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68" t="31635" r="50363" b="29679"/>
          <a:stretch/>
        </p:blipFill>
        <p:spPr>
          <a:xfrm>
            <a:off x="4680652" y="1795111"/>
            <a:ext cx="986523" cy="986533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9004EC43-0F26-2B40-8B29-48A331BEC6E2}"/>
              </a:ext>
            </a:extLst>
          </p:cNvPr>
          <p:cNvSpPr txBox="1"/>
          <p:nvPr/>
        </p:nvSpPr>
        <p:spPr>
          <a:xfrm>
            <a:off x="1519978" y="2887837"/>
            <a:ext cx="4147198" cy="123111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nusable</a:t>
            </a:r>
          </a:p>
        </p:txBody>
      </p: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E0C57880-429F-EC48-9333-0E10A85F9D5C}"/>
              </a:ext>
            </a:extLst>
          </p:cNvPr>
          <p:cNvCxnSpPr>
            <a:cxnSpLocks/>
          </p:cNvCxnSpPr>
          <p:nvPr/>
        </p:nvCxnSpPr>
        <p:spPr>
          <a:xfrm>
            <a:off x="1519977" y="2862905"/>
            <a:ext cx="4147198" cy="5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0FE349B5-3AF6-D948-890F-BFAC894055E1}"/>
              </a:ext>
            </a:extLst>
          </p:cNvPr>
          <p:cNvSpPr txBox="1"/>
          <p:nvPr/>
        </p:nvSpPr>
        <p:spPr>
          <a:xfrm rot="16200000" flipH="1">
            <a:off x="-187093" y="2226294"/>
            <a:ext cx="986525" cy="123111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TAL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n-US" sz="8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VE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60C85356-FDE9-5D40-B844-BDB571BF9D29}"/>
              </a:ext>
            </a:extLst>
          </p:cNvPr>
          <p:cNvCxnSpPr>
            <a:cxnSpLocks/>
          </p:cNvCxnSpPr>
          <p:nvPr/>
        </p:nvCxnSpPr>
        <p:spPr>
          <a:xfrm>
            <a:off x="382201" y="2864832"/>
            <a:ext cx="99037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22190125-5B4F-6C4C-A3ED-115373795386}"/>
              </a:ext>
            </a:extLst>
          </p:cNvPr>
          <p:cNvSpPr txBox="1"/>
          <p:nvPr/>
        </p:nvSpPr>
        <p:spPr>
          <a:xfrm>
            <a:off x="382200" y="2887837"/>
            <a:ext cx="990379" cy="123111"/>
          </a:xfrm>
          <a:prstGeom prst="rect">
            <a:avLst/>
          </a:prstGeom>
          <a:noFill/>
        </p:spPr>
        <p:txBody>
          <a:bodyPr wrap="square" tIns="0" bIns="0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ositive Control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DEB5815A-DA0E-CF44-9117-7876A311E0AF}"/>
              </a:ext>
            </a:extLst>
          </p:cNvPr>
          <p:cNvSpPr/>
          <p:nvPr/>
        </p:nvSpPr>
        <p:spPr>
          <a:xfrm>
            <a:off x="189000" y="3204877"/>
            <a:ext cx="6480000" cy="507831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EV2. Some MPNST PDX cells fail to grow as 3D microtissues </a:t>
            </a:r>
          </a:p>
          <a:p>
            <a:pPr algn="just"/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ative brightfield and fluorescent images of several PDX 3D microtissues stained with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cein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M (live) and DRAQ5 (total) after two days in culture. Scale bars: </a:t>
            </a:r>
            <a:r>
              <a:rPr lang="en-US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26374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290BB78-03B9-094C-82B2-84EACE0D5161}"/>
              </a:ext>
            </a:extLst>
          </p:cNvPr>
          <p:cNvSpPr/>
          <p:nvPr/>
        </p:nvSpPr>
        <p:spPr>
          <a:xfrm>
            <a:off x="189000" y="432000"/>
            <a:ext cx="6480000" cy="8280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EAC12CA6-4CD8-BE4E-8C68-4067CAD373D5}"/>
              </a:ext>
            </a:extLst>
          </p:cNvPr>
          <p:cNvGrpSpPr/>
          <p:nvPr/>
        </p:nvGrpSpPr>
        <p:grpSpPr>
          <a:xfrm>
            <a:off x="2484415" y="706209"/>
            <a:ext cx="1735878" cy="5815357"/>
            <a:chOff x="4123894" y="242383"/>
            <a:chExt cx="1735878" cy="5815357"/>
          </a:xfrm>
        </p:grpSpPr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9680D603-1C77-7745-BB6D-EF8403562C2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alphaModFix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55" t="9369" r="31400" b="14874"/>
            <a:stretch/>
          </p:blipFill>
          <p:spPr>
            <a:xfrm>
              <a:off x="4294325" y="4688664"/>
              <a:ext cx="1561289" cy="1369076"/>
            </a:xfrm>
            <a:prstGeom prst="rect">
              <a:avLst/>
            </a:prstGeom>
          </p:spPr>
        </p:pic>
        <p:pic>
          <p:nvPicPr>
            <p:cNvPr id="15" name="Content Placeholder 3">
              <a:extLst>
                <a:ext uri="{FF2B5EF4-FFF2-40B4-BE49-F238E27FC236}">
                  <a16:creationId xmlns:a16="http://schemas.microsoft.com/office/drawing/2014/main" id="{D652F63F-CEB6-9548-B2F2-4A37FAE1F8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alphaModFix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56" t="7298" r="31297" b="15237"/>
            <a:stretch/>
          </p:blipFill>
          <p:spPr bwMode="auto">
            <a:xfrm>
              <a:off x="4292575" y="3285705"/>
              <a:ext cx="1561289" cy="13775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FAA26D3D-D897-4be2-8F04-BA451C77F1D7}">
                <ma14:placeholderFlag xmlns="" xmlns:ma14="http://schemas.microsoft.com/office/mac/drawingml/2011/main" val="1"/>
              </a:ext>
            </a:extLst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C1F5889-6BBB-9B4F-B6C8-4CEEC74DA7D5}"/>
                </a:ext>
              </a:extLst>
            </p:cNvPr>
            <p:cNvSpPr txBox="1"/>
            <p:nvPr/>
          </p:nvSpPr>
          <p:spPr>
            <a:xfrm>
              <a:off x="4281631" y="242383"/>
              <a:ext cx="1568154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JH-2-079-c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983B7E32-A161-EB40-9603-92CC5CCB23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589" t="21452" r="35072" b="30671"/>
            <a:stretch/>
          </p:blipFill>
          <p:spPr>
            <a:xfrm>
              <a:off x="4286195" y="1760839"/>
              <a:ext cx="1573577" cy="1371601"/>
            </a:xfrm>
            <a:prstGeom prst="rect">
              <a:avLst/>
            </a:prstGeom>
          </p:spPr>
        </p:pic>
        <p:pic>
          <p:nvPicPr>
            <p:cNvPr id="18" name="Content Placeholder 3">
              <a:extLst>
                <a:ext uri="{FF2B5EF4-FFF2-40B4-BE49-F238E27FC236}">
                  <a16:creationId xmlns:a16="http://schemas.microsoft.com/office/drawing/2014/main" id="{D09EE244-A7E3-2D46-A238-44D5ECAD12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alphaModFix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32" t="23969" r="35227" b="31126"/>
            <a:stretch/>
          </p:blipFill>
          <p:spPr bwMode="auto">
            <a:xfrm>
              <a:off x="4281631" y="367017"/>
              <a:ext cx="1573576" cy="1371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FAA26D3D-D897-4be2-8F04-BA451C77F1D7}">
                <ma14:placeholderFlag xmlns="" xmlns:ma14="http://schemas.microsoft.com/office/mac/drawingml/2011/main" val="1"/>
              </a:ext>
            </a:extLst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7F292B9-26D5-9A4F-BE5F-29640743E275}"/>
                </a:ext>
              </a:extLst>
            </p:cNvPr>
            <p:cNvSpPr txBox="1"/>
            <p:nvPr/>
          </p:nvSpPr>
          <p:spPr>
            <a:xfrm rot="16200000">
              <a:off x="2813523" y="4605311"/>
              <a:ext cx="2771516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ay 1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FC44FC8-60C6-D347-867F-7FEB855D80C4}"/>
                </a:ext>
              </a:extLst>
            </p:cNvPr>
            <p:cNvSpPr txBox="1"/>
            <p:nvPr/>
          </p:nvSpPr>
          <p:spPr>
            <a:xfrm rot="16200000">
              <a:off x="2804430" y="1686478"/>
              <a:ext cx="276204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ay 2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9F5732F5-3CE6-004C-95C7-EE8A41DE0551}"/>
              </a:ext>
            </a:extLst>
          </p:cNvPr>
          <p:cNvGrpSpPr/>
          <p:nvPr/>
        </p:nvGrpSpPr>
        <p:grpSpPr>
          <a:xfrm>
            <a:off x="4425850" y="708104"/>
            <a:ext cx="1746758" cy="5814421"/>
            <a:chOff x="7000194" y="244278"/>
            <a:chExt cx="1746758" cy="5814421"/>
          </a:xfrm>
        </p:grpSpPr>
        <p:pic>
          <p:nvPicPr>
            <p:cNvPr id="22" name="Content Placeholder 3">
              <a:extLst>
                <a:ext uri="{FF2B5EF4-FFF2-40B4-BE49-F238E27FC236}">
                  <a16:creationId xmlns:a16="http://schemas.microsoft.com/office/drawing/2014/main" id="{A4ABECC6-80DF-0745-B7A5-0375D7A3B5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764" t="16663" r="40318" b="21857"/>
            <a:stretch/>
          </p:blipFill>
          <p:spPr>
            <a:xfrm>
              <a:off x="7176579" y="3294675"/>
              <a:ext cx="1560938" cy="1371602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299EDBF7-3C24-364C-BE8D-4986BB8D933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alphaModFix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870" t="15849" r="40079" b="22382"/>
            <a:stretch/>
          </p:blipFill>
          <p:spPr>
            <a:xfrm>
              <a:off x="7180078" y="4687097"/>
              <a:ext cx="1559663" cy="1371602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A042302-2848-064F-AFAB-4D004548DA35}"/>
                </a:ext>
              </a:extLst>
            </p:cNvPr>
            <p:cNvSpPr txBox="1"/>
            <p:nvPr/>
          </p:nvSpPr>
          <p:spPr>
            <a:xfrm>
              <a:off x="7176579" y="244278"/>
              <a:ext cx="1560938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WU-225</a:t>
              </a:r>
            </a:p>
          </p:txBody>
        </p:sp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C58E37D5-FE3E-6E46-9C27-0A3D276F255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>
              <a:alphaModFix/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76" t="35669" r="38208" b="16202"/>
            <a:stretch/>
          </p:blipFill>
          <p:spPr>
            <a:xfrm>
              <a:off x="7176579" y="1757455"/>
              <a:ext cx="1570373" cy="1371602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232082D3-7C56-2944-BCC6-996B86EF52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>
              <a:alphaModFix/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42" t="35541" r="38384" b="16317"/>
            <a:stretch/>
          </p:blipFill>
          <p:spPr>
            <a:xfrm>
              <a:off x="7179262" y="369978"/>
              <a:ext cx="1560940" cy="1371601"/>
            </a:xfrm>
            <a:prstGeom prst="rect">
              <a:avLst/>
            </a:prstGeom>
          </p:spPr>
        </p:pic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A435E85D-B239-0D4D-B5BE-496403A6DBB4}"/>
                </a:ext>
              </a:extLst>
            </p:cNvPr>
            <p:cNvSpPr txBox="1"/>
            <p:nvPr/>
          </p:nvSpPr>
          <p:spPr>
            <a:xfrm rot="16200000">
              <a:off x="5688514" y="4612093"/>
              <a:ext cx="2757952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ay 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1013472-4535-054C-B5AD-B9C9F761C317}"/>
                </a:ext>
              </a:extLst>
            </p:cNvPr>
            <p:cNvSpPr txBox="1"/>
            <p:nvPr/>
          </p:nvSpPr>
          <p:spPr>
            <a:xfrm rot="16200000">
              <a:off x="5680730" y="1685722"/>
              <a:ext cx="276204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ay 2</a:t>
              </a: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E58BFC99-1D17-EC41-BD49-186F1A9E7C1D}"/>
              </a:ext>
            </a:extLst>
          </p:cNvPr>
          <p:cNvGrpSpPr/>
          <p:nvPr/>
        </p:nvGrpSpPr>
        <p:grpSpPr>
          <a:xfrm>
            <a:off x="418098" y="706209"/>
            <a:ext cx="1911081" cy="5810246"/>
            <a:chOff x="377154" y="706209"/>
            <a:chExt cx="1911081" cy="5810246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A6585C3-611B-8C44-A507-0477F76A23A3}"/>
                </a:ext>
              </a:extLst>
            </p:cNvPr>
            <p:cNvSpPr txBox="1"/>
            <p:nvPr/>
          </p:nvSpPr>
          <p:spPr>
            <a:xfrm rot="16200000">
              <a:off x="-44288" y="1460311"/>
              <a:ext cx="1361148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rightfield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C6B9E3C-F3C2-A348-B077-EB15AE194811}"/>
                </a:ext>
              </a:extLst>
            </p:cNvPr>
            <p:cNvSpPr txBox="1"/>
            <p:nvPr/>
          </p:nvSpPr>
          <p:spPr>
            <a:xfrm rot="16200000" flipH="1">
              <a:off x="-48907" y="2846838"/>
              <a:ext cx="136746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8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VE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A9FD949C-E497-BB42-963E-F410F13E7FE8}"/>
                </a:ext>
              </a:extLst>
            </p:cNvPr>
            <p:cNvSpPr txBox="1"/>
            <p:nvPr/>
          </p:nvSpPr>
          <p:spPr>
            <a:xfrm rot="16200000">
              <a:off x="-43426" y="4368597"/>
              <a:ext cx="1361148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Brightfield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A0AE195B-853D-AD4E-ABBC-619B7AF423EB}"/>
                </a:ext>
              </a:extLst>
            </p:cNvPr>
            <p:cNvSpPr txBox="1"/>
            <p:nvPr/>
          </p:nvSpPr>
          <p:spPr>
            <a:xfrm rot="16200000" flipH="1">
              <a:off x="-48045" y="5755124"/>
              <a:ext cx="136746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8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800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VE</a:t>
              </a: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17C018CF-3AE3-904D-AD81-B6B5DBFF26D1}"/>
                </a:ext>
              </a:extLst>
            </p:cNvPr>
            <p:cNvGrpSpPr/>
            <p:nvPr/>
          </p:nvGrpSpPr>
          <p:grpSpPr>
            <a:xfrm>
              <a:off x="377154" y="706209"/>
              <a:ext cx="1911081" cy="5810246"/>
              <a:chOff x="377154" y="706209"/>
              <a:chExt cx="1911081" cy="5810246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C5DA065F-5ECF-0C46-8B08-804D52CEAB67}"/>
                  </a:ext>
                </a:extLst>
              </p:cNvPr>
              <p:cNvGrpSpPr/>
              <p:nvPr/>
            </p:nvGrpSpPr>
            <p:grpSpPr>
              <a:xfrm>
                <a:off x="377154" y="706209"/>
                <a:ext cx="1911081" cy="5810246"/>
                <a:chOff x="1062206" y="242383"/>
                <a:chExt cx="1911081" cy="5810246"/>
              </a:xfrm>
            </p:grpSpPr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27236C04-2F5F-114D-9333-974D48D5F49D}"/>
                    </a:ext>
                  </a:extLst>
                </p:cNvPr>
                <p:cNvSpPr txBox="1"/>
                <p:nvPr/>
              </p:nvSpPr>
              <p:spPr>
                <a:xfrm rot="16200000">
                  <a:off x="-250743" y="1686478"/>
                  <a:ext cx="2762040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 2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DF5011BF-55FC-A645-9EA1-D900BD4AA8DB}"/>
                    </a:ext>
                  </a:extLst>
                </p:cNvPr>
                <p:cNvSpPr txBox="1"/>
                <p:nvPr/>
              </p:nvSpPr>
              <p:spPr>
                <a:xfrm rot="16200000">
                  <a:off x="-261995" y="4605316"/>
                  <a:ext cx="2771514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ay 7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2C577B1B-7F95-BC4C-8991-79264ABF9A6D}"/>
                    </a:ext>
                  </a:extLst>
                </p:cNvPr>
                <p:cNvSpPr txBox="1"/>
                <p:nvPr/>
              </p:nvSpPr>
              <p:spPr>
                <a:xfrm>
                  <a:off x="1395933" y="242383"/>
                  <a:ext cx="1573578" cy="12311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N-2</a:t>
                  </a:r>
                </a:p>
              </p:txBody>
            </p:sp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95A5C219-3D33-B148-8137-180A98E0BD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3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728" t="34312" r="29373" b="17527"/>
                <a:stretch/>
              </p:blipFill>
              <p:spPr>
                <a:xfrm>
                  <a:off x="1399708" y="367017"/>
                  <a:ext cx="1573579" cy="1376372"/>
                </a:xfrm>
                <a:prstGeom prst="rect">
                  <a:avLst/>
                </a:prstGeom>
              </p:spPr>
            </p:pic>
            <p:pic>
              <p:nvPicPr>
                <p:cNvPr id="10" name="Picture 9">
                  <a:extLst>
                    <a:ext uri="{FF2B5EF4-FFF2-40B4-BE49-F238E27FC236}">
                      <a16:creationId xmlns:a16="http://schemas.microsoft.com/office/drawing/2014/main" id="{BE7654B7-96AD-BD4C-982D-7D87C58C2F3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5576" t="32434" r="29233" b="17296"/>
                <a:stretch/>
              </p:blipFill>
              <p:spPr>
                <a:xfrm>
                  <a:off x="1399138" y="1758087"/>
                  <a:ext cx="1570373" cy="1376375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DB5E4CA1-52DF-5E4D-B703-25095E699B6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7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sharpenSoften amoun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698" t="16147" r="31366" b="23857"/>
                <a:stretch/>
              </p:blipFill>
              <p:spPr>
                <a:xfrm>
                  <a:off x="1399138" y="4676256"/>
                  <a:ext cx="1570373" cy="1376373"/>
                </a:xfrm>
                <a:prstGeom prst="rect">
                  <a:avLst/>
                </a:prstGeom>
              </p:spPr>
            </p:pic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EF71A5E9-1385-E24D-BC4B-31208368192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9">
                  <a:alphaModFix/>
                  <a:extLst>
                    <a:ext uri="{BEBA8EAE-BF5A-486C-A8C5-ECC9F3942E4B}">
                      <a14:imgProps xmlns:a14="http://schemas.microsoft.com/office/drawing/2010/main">
                        <a14:imgLayer r:embed="rId20">
                          <a14:imgEffect>
                            <a14:sharpenSoften amount="2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776" t="16450" r="31362" b="23905"/>
                <a:stretch/>
              </p:blipFill>
              <p:spPr>
                <a:xfrm>
                  <a:off x="1399138" y="3281117"/>
                  <a:ext cx="1570373" cy="1371602"/>
                </a:xfrm>
                <a:prstGeom prst="rect">
                  <a:avLst/>
                </a:prstGeom>
              </p:spPr>
            </p:pic>
          </p:grp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id="{06B00396-CF59-A04E-8A62-48F4FD2D186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24193" y="830843"/>
                <a:ext cx="2173" cy="276744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id="{AE368832-4167-5143-8552-8E40B41C29A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516560" y="3735871"/>
                <a:ext cx="2173" cy="2767445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6" name="Rectangle 35">
            <a:extLst>
              <a:ext uri="{FF2B5EF4-FFF2-40B4-BE49-F238E27FC236}">
                <a16:creationId xmlns:a16="http://schemas.microsoft.com/office/drawing/2014/main" id="{6D3DB458-0D18-5845-8F4D-5DE6DC55058F}"/>
              </a:ext>
            </a:extLst>
          </p:cNvPr>
          <p:cNvSpPr/>
          <p:nvPr/>
        </p:nvSpPr>
        <p:spPr>
          <a:xfrm>
            <a:off x="189000" y="6702992"/>
            <a:ext cx="6480000" cy="646331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EV3. Some PDX 3D microtissues remodel their collagen matrix</a:t>
            </a:r>
            <a:endParaRPr lang="en-US" sz="9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ative brightfield and fluorescent images showing MN-2 and JH-2-079-c microtissues remodeling the collagen matrix at different time points with the WU-225 matrix unchanged. Cells were stained with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lcein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M (live) and DRAQ5 (total). Scale bars: </a:t>
            </a:r>
            <a:r>
              <a:rPr lang="en-US" sz="9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µm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338404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290BB78-03B9-094C-82B2-84EACE0D5161}"/>
              </a:ext>
            </a:extLst>
          </p:cNvPr>
          <p:cNvSpPr/>
          <p:nvPr/>
        </p:nvSpPr>
        <p:spPr>
          <a:xfrm>
            <a:off x="189000" y="432000"/>
            <a:ext cx="6480000" cy="8280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1662026-C8D6-5B47-B8E0-175B2A586181}"/>
              </a:ext>
            </a:extLst>
          </p:cNvPr>
          <p:cNvSpPr txBox="1"/>
          <p:nvPr/>
        </p:nvSpPr>
        <p:spPr>
          <a:xfrm>
            <a:off x="339846" y="1280932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A80DA6CE-011E-3B4A-9163-0B8D43522ADB}"/>
              </a:ext>
            </a:extLst>
          </p:cNvPr>
          <p:cNvSpPr txBox="1"/>
          <p:nvPr/>
        </p:nvSpPr>
        <p:spPr>
          <a:xfrm>
            <a:off x="1219497" y="4346568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76BFE05-4617-444F-8A47-D97D9716DBF2}"/>
              </a:ext>
            </a:extLst>
          </p:cNvPr>
          <p:cNvSpPr txBox="1"/>
          <p:nvPr/>
        </p:nvSpPr>
        <p:spPr>
          <a:xfrm rot="16200000">
            <a:off x="-681305" y="2578648"/>
            <a:ext cx="2060993" cy="2154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% Cell Viability</a:t>
            </a:r>
          </a:p>
          <a:p>
            <a:pPr algn="ctr"/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(normalized to DMSO control)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1705B129-2926-7747-A783-F831ADBB31DA}"/>
              </a:ext>
            </a:extLst>
          </p:cNvPr>
          <p:cNvGrpSpPr/>
          <p:nvPr/>
        </p:nvGrpSpPr>
        <p:grpSpPr>
          <a:xfrm>
            <a:off x="468499" y="2853404"/>
            <a:ext cx="6430504" cy="1177701"/>
            <a:chOff x="468499" y="2853404"/>
            <a:chExt cx="6430504" cy="1177701"/>
          </a:xfrm>
        </p:grpSpPr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8204C125-85DD-3349-925D-84161ED83736}"/>
                </a:ext>
              </a:extLst>
            </p:cNvPr>
            <p:cNvSpPr txBox="1"/>
            <p:nvPr/>
          </p:nvSpPr>
          <p:spPr>
            <a:xfrm>
              <a:off x="714828" y="3923383"/>
              <a:ext cx="5344001" cy="107722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Drug Concentration Log(M)</a:t>
              </a:r>
            </a:p>
          </p:txBody>
        </p: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2BDD4139-6FB8-7245-B695-34020C7A0A5A}"/>
                </a:ext>
              </a:extLst>
            </p:cNvPr>
            <p:cNvGrpSpPr/>
            <p:nvPr/>
          </p:nvGrpSpPr>
          <p:grpSpPr>
            <a:xfrm>
              <a:off x="468499" y="2853404"/>
              <a:ext cx="6430504" cy="1044614"/>
              <a:chOff x="468499" y="2853404"/>
              <a:chExt cx="6430504" cy="1044614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5D83F3F1-210B-4044-8205-DA7B6A4A72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610590" y="2856618"/>
                <a:ext cx="1574800" cy="1041400"/>
              </a:xfrm>
              <a:prstGeom prst="rect">
                <a:avLst/>
              </a:prstGeom>
            </p:spPr>
          </p:pic>
          <p:pic>
            <p:nvPicPr>
              <p:cNvPr id="75" name="Picture 74">
                <a:extLst>
                  <a:ext uri="{FF2B5EF4-FFF2-40B4-BE49-F238E27FC236}">
                    <a16:creationId xmlns:a16="http://schemas.microsoft.com/office/drawing/2014/main" id="{C8DE828C-78D9-E949-B857-A2B6DC5E088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6544" r="31327"/>
              <a:stretch/>
            </p:blipFill>
            <p:spPr>
              <a:xfrm>
                <a:off x="5866308" y="3027014"/>
                <a:ext cx="204305" cy="633602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444F7361-B15C-6743-B2B3-A475658BD7B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68499" y="2853404"/>
                <a:ext cx="1578732" cy="1044000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331B06D9-0263-2D4A-8675-966F73A29DA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823884" y="2853404"/>
                <a:ext cx="1574800" cy="1041400"/>
              </a:xfrm>
              <a:prstGeom prst="rect">
                <a:avLst/>
              </a:prstGeom>
            </p:spPr>
          </p:pic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5668F9B6-706A-F245-8BF4-235B5C43BC2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3161589" y="2855374"/>
                <a:ext cx="1574800" cy="1041400"/>
              </a:xfrm>
              <a:prstGeom prst="rect">
                <a:avLst/>
              </a:prstGeom>
            </p:spPr>
          </p:pic>
          <p:grpSp>
            <p:nvGrpSpPr>
              <p:cNvPr id="74" name="Group 73">
                <a:extLst>
                  <a:ext uri="{FF2B5EF4-FFF2-40B4-BE49-F238E27FC236}">
                    <a16:creationId xmlns:a16="http://schemas.microsoft.com/office/drawing/2014/main" id="{A8A2FA69-D470-9E45-B019-90CE5274DFF7}"/>
                  </a:ext>
                </a:extLst>
              </p:cNvPr>
              <p:cNvGrpSpPr/>
              <p:nvPr/>
            </p:nvGrpSpPr>
            <p:grpSpPr>
              <a:xfrm>
                <a:off x="6082233" y="3114802"/>
                <a:ext cx="816770" cy="406022"/>
                <a:chOff x="6082233" y="3114802"/>
                <a:chExt cx="816770" cy="406022"/>
              </a:xfrm>
            </p:grpSpPr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45A80D0B-BF96-6F48-83C2-F89532175B65}"/>
                    </a:ext>
                  </a:extLst>
                </p:cNvPr>
                <p:cNvSpPr txBox="1"/>
                <p:nvPr/>
              </p:nvSpPr>
              <p:spPr>
                <a:xfrm>
                  <a:off x="6082233" y="3114802"/>
                  <a:ext cx="816770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olaparib</a:t>
                  </a:r>
                  <a:endParaRPr lang="en-US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61E9A9AB-40A2-0440-AB2E-458DCE55526A}"/>
                    </a:ext>
                  </a:extLst>
                </p:cNvPr>
                <p:cNvSpPr txBox="1"/>
                <p:nvPr/>
              </p:nvSpPr>
              <p:spPr>
                <a:xfrm>
                  <a:off x="6082233" y="3267241"/>
                  <a:ext cx="816770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rabectedin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F70FEF92-10DF-264F-89BC-E0E095C56F7D}"/>
                    </a:ext>
                  </a:extLst>
                </p:cNvPr>
                <p:cNvSpPr txBox="1"/>
                <p:nvPr/>
              </p:nvSpPr>
              <p:spPr>
                <a:xfrm>
                  <a:off x="6082233" y="3413102"/>
                  <a:ext cx="816770" cy="10772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mbo 1:2000</a:t>
                  </a:r>
                </a:p>
              </p:txBody>
            </p:sp>
          </p:grpSp>
        </p:grpSp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E8725E6-01FD-6E48-AFE2-AD5C5B046B11}"/>
              </a:ext>
            </a:extLst>
          </p:cNvPr>
          <p:cNvGrpSpPr/>
          <p:nvPr/>
        </p:nvGrpSpPr>
        <p:grpSpPr>
          <a:xfrm>
            <a:off x="478644" y="1469356"/>
            <a:ext cx="6420359" cy="1133502"/>
            <a:chOff x="478644" y="1469356"/>
            <a:chExt cx="6420359" cy="1133502"/>
          </a:xfrm>
        </p:grpSpPr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E41E6588-5093-5846-A5A5-550FC2C0DA10}"/>
                </a:ext>
              </a:extLst>
            </p:cNvPr>
            <p:cNvGrpSpPr/>
            <p:nvPr/>
          </p:nvGrpSpPr>
          <p:grpSpPr>
            <a:xfrm>
              <a:off x="4514364" y="1469356"/>
              <a:ext cx="1790700" cy="1125899"/>
              <a:chOff x="4579681" y="1472528"/>
              <a:chExt cx="1790700" cy="1125899"/>
            </a:xfrm>
          </p:grpSpPr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id="{4ADDF20A-CF58-6E47-886E-A6DDAC3D7F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4579681" y="1493527"/>
                <a:ext cx="1790700" cy="1104900"/>
              </a:xfrm>
              <a:prstGeom prst="rect">
                <a:avLst/>
              </a:prstGeom>
            </p:spPr>
          </p:pic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6AA7FEEC-7188-9647-A0DB-7A1551E9CECC}"/>
                  </a:ext>
                </a:extLst>
              </p:cNvPr>
              <p:cNvSpPr txBox="1"/>
              <p:nvPr/>
            </p:nvSpPr>
            <p:spPr>
              <a:xfrm>
                <a:off x="4905032" y="1472528"/>
                <a:ext cx="11412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WU-225</a:t>
                </a:r>
              </a:p>
            </p:txBody>
          </p:sp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5F8D5176-B921-DA4E-B130-8AC9F45A8DAF}"/>
                </a:ext>
              </a:extLst>
            </p:cNvPr>
            <p:cNvGrpSpPr/>
            <p:nvPr/>
          </p:nvGrpSpPr>
          <p:grpSpPr>
            <a:xfrm>
              <a:off x="3101390" y="1469356"/>
              <a:ext cx="1790700" cy="1133502"/>
              <a:chOff x="3144936" y="1469356"/>
              <a:chExt cx="1790700" cy="1133502"/>
            </a:xfrm>
          </p:grpSpPr>
          <p:pic>
            <p:nvPicPr>
              <p:cNvPr id="40" name="Picture 39">
                <a:extLst>
                  <a:ext uri="{FF2B5EF4-FFF2-40B4-BE49-F238E27FC236}">
                    <a16:creationId xmlns:a16="http://schemas.microsoft.com/office/drawing/2014/main" id="{04894ABC-1933-D747-9229-5BE8E0AD98A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144936" y="1497958"/>
                <a:ext cx="1790700" cy="1104900"/>
              </a:xfrm>
              <a:prstGeom prst="rect">
                <a:avLst/>
              </a:prstGeom>
            </p:spPr>
          </p:pic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C4C827A4-9FB0-5448-858E-ADFF20C62D8C}"/>
                  </a:ext>
                </a:extLst>
              </p:cNvPr>
              <p:cNvSpPr txBox="1"/>
              <p:nvPr/>
            </p:nvSpPr>
            <p:spPr>
              <a:xfrm>
                <a:off x="3469247" y="1469356"/>
                <a:ext cx="11412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JH-2-079-c</a:t>
                </a:r>
              </a:p>
            </p:txBody>
          </p:sp>
        </p:grp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839D9224-D8EE-5744-8067-607904A900DC}"/>
                </a:ext>
              </a:extLst>
            </p:cNvPr>
            <p:cNvGrpSpPr/>
            <p:nvPr/>
          </p:nvGrpSpPr>
          <p:grpSpPr>
            <a:xfrm>
              <a:off x="478644" y="1469356"/>
              <a:ext cx="1587500" cy="1133502"/>
              <a:chOff x="478644" y="1469356"/>
              <a:chExt cx="1587500" cy="1133502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14E06819-6E9F-EB4F-8DCD-7680CAC372D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78644" y="1536058"/>
                <a:ext cx="1587500" cy="1066800"/>
              </a:xfrm>
              <a:prstGeom prst="rect">
                <a:avLst/>
              </a:prstGeom>
            </p:spPr>
          </p:pic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E570D348-5B79-A349-8E4E-3F964BC5BF13}"/>
                  </a:ext>
                </a:extLst>
              </p:cNvPr>
              <p:cNvSpPr txBox="1"/>
              <p:nvPr/>
            </p:nvSpPr>
            <p:spPr>
              <a:xfrm>
                <a:off x="706630" y="1469356"/>
                <a:ext cx="11412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MN-2</a:t>
                </a:r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934D9260-CC6D-2F4C-8BB4-19F848591441}"/>
                </a:ext>
              </a:extLst>
            </p:cNvPr>
            <p:cNvGrpSpPr/>
            <p:nvPr/>
          </p:nvGrpSpPr>
          <p:grpSpPr>
            <a:xfrm>
              <a:off x="1688417" y="1469356"/>
              <a:ext cx="1790700" cy="1129071"/>
              <a:chOff x="1710190" y="1469356"/>
              <a:chExt cx="1790700" cy="1129071"/>
            </a:xfrm>
          </p:grpSpPr>
          <p:pic>
            <p:nvPicPr>
              <p:cNvPr id="52" name="Picture 51">
                <a:extLst>
                  <a:ext uri="{FF2B5EF4-FFF2-40B4-BE49-F238E27FC236}">
                    <a16:creationId xmlns:a16="http://schemas.microsoft.com/office/drawing/2014/main" id="{CA41DBD9-1F81-BA44-8D82-2E4482D7A4B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710190" y="1493527"/>
                <a:ext cx="1790700" cy="1104900"/>
              </a:xfrm>
              <a:prstGeom prst="rect">
                <a:avLst/>
              </a:prstGeom>
            </p:spPr>
          </p:pic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4B37F32C-C15A-D549-8CAA-3079C4913F63}"/>
                  </a:ext>
                </a:extLst>
              </p:cNvPr>
              <p:cNvSpPr txBox="1"/>
              <p:nvPr/>
            </p:nvSpPr>
            <p:spPr>
              <a:xfrm>
                <a:off x="2041895" y="1469356"/>
                <a:ext cx="1141200" cy="123111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JH-2-002</a:t>
                </a:r>
              </a:p>
            </p:txBody>
          </p: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EDA56A48-376F-C64B-818D-4DDDAB91F5F0}"/>
                </a:ext>
              </a:extLst>
            </p:cNvPr>
            <p:cNvGrpSpPr/>
            <p:nvPr/>
          </p:nvGrpSpPr>
          <p:grpSpPr>
            <a:xfrm>
              <a:off x="5858564" y="1655874"/>
              <a:ext cx="1040439" cy="575078"/>
              <a:chOff x="5858564" y="1655874"/>
              <a:chExt cx="1040439" cy="575078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BE41F5A7-D87F-2843-81BB-DE9051B97B4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72814" t="63770" r="19702"/>
              <a:stretch/>
            </p:blipFill>
            <p:spPr>
              <a:xfrm>
                <a:off x="5858564" y="1655874"/>
                <a:ext cx="220083" cy="575078"/>
              </a:xfrm>
              <a:prstGeom prst="rect">
                <a:avLst/>
              </a:prstGeom>
            </p:spPr>
          </p:pic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9FE725EF-052D-5D45-8886-189E44F0F399}"/>
                  </a:ext>
                </a:extLst>
              </p:cNvPr>
              <p:cNvSpPr txBox="1"/>
              <p:nvPr/>
            </p:nvSpPr>
            <p:spPr>
              <a:xfrm>
                <a:off x="6078647" y="1889638"/>
                <a:ext cx="81677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trabectedin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11FB4EFC-5A3C-284B-9AA4-03A01D112C01}"/>
                  </a:ext>
                </a:extLst>
              </p:cNvPr>
              <p:cNvSpPr txBox="1"/>
              <p:nvPr/>
            </p:nvSpPr>
            <p:spPr>
              <a:xfrm>
                <a:off x="6082233" y="1734272"/>
                <a:ext cx="81677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rdametinib</a:t>
                </a:r>
                <a:endParaRPr 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0CD46AB8-8EFA-F945-B4E0-3717EA56CC24}"/>
                  </a:ext>
                </a:extLst>
              </p:cNvPr>
              <p:cNvSpPr txBox="1"/>
              <p:nvPr/>
            </p:nvSpPr>
            <p:spPr>
              <a:xfrm>
                <a:off x="6082233" y="2025981"/>
                <a:ext cx="816770" cy="107722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combo 1:2000</a:t>
                </a:r>
              </a:p>
            </p:txBody>
          </p:sp>
        </p:grpSp>
      </p:grpSp>
      <p:pic>
        <p:nvPicPr>
          <p:cNvPr id="6" name="Picture 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88417" y="4417120"/>
            <a:ext cx="3930185" cy="3439551"/>
          </a:xfrm>
          <a:prstGeom prst="rect">
            <a:avLst/>
          </a:prstGeom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67523C00-2E73-224F-9D18-66082A310565}"/>
              </a:ext>
            </a:extLst>
          </p:cNvPr>
          <p:cNvSpPr/>
          <p:nvPr/>
        </p:nvSpPr>
        <p:spPr>
          <a:xfrm>
            <a:off x="189000" y="7915098"/>
            <a:ext cx="6480000" cy="784830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EV4. PDX 3D microtissue data in response to drugs</a:t>
            </a:r>
          </a:p>
          <a:p>
            <a:pPr marL="228600" indent="-228600" algn="just">
              <a:buFont typeface="+mj-lt"/>
              <a:buAutoNum type="alphaUcPeriod"/>
            </a:pP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se response curves of four PDX 3D microtissues exposed to trabectedin combinations with either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rdametinib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laparib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at drug ratios of 1:2000 after two days in culture. Data points and error bars represent </a:t>
            </a:r>
            <a:r>
              <a:rPr lang="en-US" sz="9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n≥10.</a:t>
            </a:r>
          </a:p>
          <a:p>
            <a:pPr marL="228600" indent="-228600" algn="just">
              <a:buFont typeface="+mj-lt"/>
              <a:buAutoNum type="alphaUcPeriod"/>
            </a:pPr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rea under the curve (AUC) of single agents and trabectedin combinations from panel A. Error bars drawn from bootstrap across the various experiments.</a:t>
            </a:r>
            <a:endParaRPr lang="en-US" sz="9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5863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290BB78-03B9-094C-82B2-84EACE0D5161}"/>
              </a:ext>
            </a:extLst>
          </p:cNvPr>
          <p:cNvSpPr/>
          <p:nvPr/>
        </p:nvSpPr>
        <p:spPr>
          <a:xfrm>
            <a:off x="240658" y="432000"/>
            <a:ext cx="6480000" cy="8280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2282" y="1040229"/>
            <a:ext cx="4095227" cy="6010566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AF5DA237-D7D7-6E46-9DB9-F99111FAABC3}"/>
              </a:ext>
            </a:extLst>
          </p:cNvPr>
          <p:cNvSpPr/>
          <p:nvPr/>
        </p:nvSpPr>
        <p:spPr>
          <a:xfrm>
            <a:off x="242165" y="7149556"/>
            <a:ext cx="6480000" cy="507831"/>
          </a:xfrm>
          <a:prstGeom prst="rect">
            <a:avLst/>
          </a:prstGeom>
          <a:solidFill>
            <a:schemeClr val="bg1">
              <a:lumMod val="95000"/>
            </a:schemeClr>
          </a:solidFill>
        </p:spPr>
        <p:txBody>
          <a:bodyPr wrap="square">
            <a:spAutoFit/>
          </a:bodyPr>
          <a:lstStyle/>
          <a:p>
            <a:pPr algn="just"/>
            <a:r>
              <a:rPr lang="en-US" sz="9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EV5. Differentially expressed genes across PDX</a:t>
            </a:r>
          </a:p>
          <a:p>
            <a:pPr algn="just"/>
            <a:r>
              <a:rPr lang="en-US" sz="9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eatmap depicting 525 differentially expressed genes across 9 PDX engineered into microtissues categorized as “robust”, “good”, or “unusable”.</a:t>
            </a:r>
            <a:endParaRPr lang="en-US" sz="900" b="1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8213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82</Words>
  <Application>Microsoft Office PowerPoint</Application>
  <PresentationFormat>On-screen Show (4:3)</PresentationFormat>
  <Paragraphs>6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Washingt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manshi Bhatia</dc:creator>
  <cp:lastModifiedBy>Himanshi Bhatia</cp:lastModifiedBy>
  <cp:revision>1</cp:revision>
  <dcterms:created xsi:type="dcterms:W3CDTF">2022-04-29T20:20:28Z</dcterms:created>
  <dcterms:modified xsi:type="dcterms:W3CDTF">2022-04-29T20:21:03Z</dcterms:modified>
</cp:coreProperties>
</file>